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57" r:id="rId2"/>
    <p:sldId id="256" r:id="rId3"/>
    <p:sldId id="258" r:id="rId4"/>
    <p:sldId id="259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48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1B45DD6-4660-40DA-8231-4ED1AB2DB74A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C858E6-340A-40AA-A85F-A36CFB51187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46144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1C858E6-340A-40AA-A85F-A36CFB511872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37295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F7F1B-CF2F-43DC-8E1D-979E3D3BBAB7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3DE3B-70E3-48ED-A93B-F6ADEDFD2F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18550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F7F1B-CF2F-43DC-8E1D-979E3D3BBAB7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3DE3B-70E3-48ED-A93B-F6ADEDFD2F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87951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F7F1B-CF2F-43DC-8E1D-979E3D3BBAB7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3DE3B-70E3-48ED-A93B-F6ADEDFD2F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8920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F7F1B-CF2F-43DC-8E1D-979E3D3BBAB7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3DE3B-70E3-48ED-A93B-F6ADEDFD2F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32806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F7F1B-CF2F-43DC-8E1D-979E3D3BBAB7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3DE3B-70E3-48ED-A93B-F6ADEDFD2F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48001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F7F1B-CF2F-43DC-8E1D-979E3D3BBAB7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3DE3B-70E3-48ED-A93B-F6ADEDFD2F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820690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F7F1B-CF2F-43DC-8E1D-979E3D3BBAB7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3DE3B-70E3-48ED-A93B-F6ADEDFD2F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77815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F7F1B-CF2F-43DC-8E1D-979E3D3BBAB7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3DE3B-70E3-48ED-A93B-F6ADEDFD2F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20827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F7F1B-CF2F-43DC-8E1D-979E3D3BBAB7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3DE3B-70E3-48ED-A93B-F6ADEDFD2F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5859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F7F1B-CF2F-43DC-8E1D-979E3D3BBAB7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3DE3B-70E3-48ED-A93B-F6ADEDFD2F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75453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EF7F1B-CF2F-43DC-8E1D-979E3D3BBAB7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13DE3B-70E3-48ED-A93B-F6ADEDFD2F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0850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EF7F1B-CF2F-43DC-8E1D-979E3D3BBAB7}" type="datetimeFigureOut">
              <a:rPr lang="zh-CN" altLang="en-US" smtClean="0"/>
              <a:t>2020-10-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13DE3B-70E3-48ED-A93B-F6ADEDFD2F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2959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tiff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jpeg"/><Relationship Id="rId4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62" t="22033" r="17363" b="24577"/>
          <a:stretch/>
        </p:blipFill>
        <p:spPr>
          <a:xfrm>
            <a:off x="2704280" y="2503532"/>
            <a:ext cx="2792505" cy="213570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文本框 4"/>
          <p:cNvSpPr txBox="1"/>
          <p:nvPr/>
        </p:nvSpPr>
        <p:spPr>
          <a:xfrm>
            <a:off x="2946332" y="1004337"/>
            <a:ext cx="2678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: APEX2-FLAG-GRB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2099169" y="1837767"/>
            <a:ext cx="6320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Dox:     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789449" y="1837767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3197342" y="1837767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3506623" y="1837767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3860728" y="1837767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4165528" y="1837767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4479292" y="1837767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4788573" y="1837767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5142678" y="1837767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2103651" y="2164978"/>
            <a:ext cx="9054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</a:t>
            </a:r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O</a:t>
            </a:r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:     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2793932" y="2164978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3201825" y="2164978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3511106" y="2164978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3865211" y="2164978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4170011" y="2164978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4483775" y="2164978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4793056" y="2164978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5147161" y="2164978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4" name="直接连接符 23"/>
          <p:cNvCxnSpPr/>
          <p:nvPr/>
        </p:nvCxnSpPr>
        <p:spPr>
          <a:xfrm>
            <a:off x="2838756" y="1721223"/>
            <a:ext cx="126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直接连接符 24"/>
          <p:cNvCxnSpPr/>
          <p:nvPr/>
        </p:nvCxnSpPr>
        <p:spPr>
          <a:xfrm>
            <a:off x="4255175" y="1752600"/>
            <a:ext cx="126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文本框 25"/>
          <p:cNvSpPr txBox="1"/>
          <p:nvPr/>
        </p:nvSpPr>
        <p:spPr>
          <a:xfrm>
            <a:off x="3186369" y="1398494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1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4589340" y="1429871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29" name="图片 28"/>
          <p:cNvPicPr>
            <a:picLocks noChangeAspect="1"/>
          </p:cNvPicPr>
          <p:nvPr/>
        </p:nvPicPr>
        <p:blipFill rotWithShape="1">
          <a:blip r:embed="rId4"/>
          <a:srcRect b="17228"/>
          <a:stretch/>
        </p:blipFill>
        <p:spPr>
          <a:xfrm>
            <a:off x="2701222" y="4708711"/>
            <a:ext cx="2795563" cy="49530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图片 2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827" t="45341" r="15366" b="42237"/>
          <a:stretch/>
        </p:blipFill>
        <p:spPr>
          <a:xfrm>
            <a:off x="2708686" y="5253319"/>
            <a:ext cx="2806489" cy="53788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1" name="文本框 30"/>
          <p:cNvSpPr txBox="1"/>
          <p:nvPr/>
        </p:nvSpPr>
        <p:spPr>
          <a:xfrm>
            <a:off x="5515175" y="3571383"/>
            <a:ext cx="17668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treptavidin-HRP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5519658" y="4732308"/>
            <a:ext cx="11416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GRB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5524141" y="5288118"/>
            <a:ext cx="12009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</a:t>
            </a:r>
            <a:r>
              <a:rPr lang="el-GR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β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actin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2220185" y="5390282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6" name="直接连接符 35"/>
          <p:cNvCxnSpPr/>
          <p:nvPr/>
        </p:nvCxnSpPr>
        <p:spPr>
          <a:xfrm>
            <a:off x="2614640" y="5544671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文本框 40"/>
          <p:cNvSpPr txBox="1"/>
          <p:nvPr/>
        </p:nvSpPr>
        <p:spPr>
          <a:xfrm>
            <a:off x="2197774" y="4803097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42" name="直接连接符 41"/>
          <p:cNvCxnSpPr/>
          <p:nvPr/>
        </p:nvCxnSpPr>
        <p:spPr>
          <a:xfrm>
            <a:off x="2592229" y="4957486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文本框 42"/>
          <p:cNvSpPr txBox="1"/>
          <p:nvPr/>
        </p:nvSpPr>
        <p:spPr>
          <a:xfrm>
            <a:off x="2188810" y="4605875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7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44" name="直接连接符 43"/>
          <p:cNvCxnSpPr/>
          <p:nvPr/>
        </p:nvCxnSpPr>
        <p:spPr>
          <a:xfrm>
            <a:off x="2583265" y="4760264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文本框 44"/>
          <p:cNvSpPr txBox="1"/>
          <p:nvPr/>
        </p:nvSpPr>
        <p:spPr>
          <a:xfrm>
            <a:off x="392189" y="390979"/>
            <a:ext cx="40575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3b. Replicate 1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1726787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50" t="41818" r="17392" b="44363"/>
          <a:stretch/>
        </p:blipFill>
        <p:spPr>
          <a:xfrm>
            <a:off x="2502580" y="5015754"/>
            <a:ext cx="3418355" cy="59167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rcRect l="861"/>
          <a:stretch/>
        </p:blipFill>
        <p:spPr>
          <a:xfrm>
            <a:off x="2502580" y="2906525"/>
            <a:ext cx="3418355" cy="20669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74" t="43347" r="20224" b="41598"/>
          <a:stretch/>
        </p:blipFill>
        <p:spPr>
          <a:xfrm>
            <a:off x="2502579" y="5649728"/>
            <a:ext cx="3418355" cy="71073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文本框 7"/>
          <p:cNvSpPr txBox="1"/>
          <p:nvPr/>
        </p:nvSpPr>
        <p:spPr>
          <a:xfrm>
            <a:off x="2932885" y="1394302"/>
            <a:ext cx="2678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: APEX2-FLAG-GRB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2085722" y="2227732"/>
            <a:ext cx="6320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Dox:     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776002" y="2227732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3183895" y="2227732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493176" y="2227732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847281" y="2227732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4447915" y="2227732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4855808" y="2227732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5165089" y="2227732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5519194" y="2227732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2090204" y="2554943"/>
            <a:ext cx="9054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</a:t>
            </a:r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O</a:t>
            </a:r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:     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2780485" y="2554943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3188378" y="2554943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3497659" y="2554943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3851764" y="2554943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4452398" y="2554943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4860291" y="2554943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5169572" y="2554943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5523677" y="2554943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5920934" y="3939987"/>
            <a:ext cx="17668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treptavidin-HRP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5916835" y="5053510"/>
            <a:ext cx="221246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FLAG </a:t>
            </a:r>
            <a:endParaRPr lang="en-US" altLang="zh-CN" sz="1600" dirty="0" smtClean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APEX2-FLAG-GRB2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5921318" y="5837919"/>
            <a:ext cx="12009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</a:t>
            </a:r>
            <a:r>
              <a:rPr lang="el-GR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β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actin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1991586" y="5834035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7" name="直接连接符 36"/>
          <p:cNvCxnSpPr/>
          <p:nvPr/>
        </p:nvCxnSpPr>
        <p:spPr>
          <a:xfrm>
            <a:off x="2825309" y="2111188"/>
            <a:ext cx="126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>
            <a:off x="4537562" y="2142565"/>
            <a:ext cx="126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文本框 38"/>
          <p:cNvSpPr txBox="1"/>
          <p:nvPr/>
        </p:nvSpPr>
        <p:spPr>
          <a:xfrm>
            <a:off x="3172922" y="1788459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1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4871727" y="1819836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41" name="直接连接符 40"/>
          <p:cNvCxnSpPr/>
          <p:nvPr/>
        </p:nvCxnSpPr>
        <p:spPr>
          <a:xfrm>
            <a:off x="2390524" y="5988424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文本框 41"/>
          <p:cNvSpPr txBox="1"/>
          <p:nvPr/>
        </p:nvSpPr>
        <p:spPr>
          <a:xfrm>
            <a:off x="1982622" y="555613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43" name="直接连接符 42"/>
          <p:cNvCxnSpPr/>
          <p:nvPr/>
        </p:nvCxnSpPr>
        <p:spPr>
          <a:xfrm>
            <a:off x="2390524" y="5710520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文本框 43"/>
          <p:cNvSpPr txBox="1"/>
          <p:nvPr/>
        </p:nvSpPr>
        <p:spPr>
          <a:xfrm>
            <a:off x="1996069" y="6174693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3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45" name="直接连接符 44"/>
          <p:cNvCxnSpPr/>
          <p:nvPr/>
        </p:nvCxnSpPr>
        <p:spPr>
          <a:xfrm>
            <a:off x="2390524" y="6329082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6" name="文本框 45"/>
          <p:cNvSpPr txBox="1"/>
          <p:nvPr/>
        </p:nvSpPr>
        <p:spPr>
          <a:xfrm>
            <a:off x="1982622" y="5273744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47" name="直接连接符 46"/>
          <p:cNvCxnSpPr/>
          <p:nvPr/>
        </p:nvCxnSpPr>
        <p:spPr>
          <a:xfrm>
            <a:off x="2390524" y="5428133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文本框 47"/>
          <p:cNvSpPr txBox="1"/>
          <p:nvPr/>
        </p:nvSpPr>
        <p:spPr>
          <a:xfrm>
            <a:off x="1973658" y="5076522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7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49" name="直接连接符 48"/>
          <p:cNvCxnSpPr/>
          <p:nvPr/>
        </p:nvCxnSpPr>
        <p:spPr>
          <a:xfrm>
            <a:off x="2390524" y="5230911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文本框 1"/>
          <p:cNvSpPr txBox="1"/>
          <p:nvPr/>
        </p:nvSpPr>
        <p:spPr>
          <a:xfrm>
            <a:off x="392189" y="390979"/>
            <a:ext cx="40575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3b. Replicate 2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0063873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92189" y="390979"/>
            <a:ext cx="40575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3b. Replicate 3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/>
          <a:srcRect l="6992" t="4749" r="15580" b="4445"/>
          <a:stretch/>
        </p:blipFill>
        <p:spPr>
          <a:xfrm>
            <a:off x="2568389" y="2783541"/>
            <a:ext cx="2717727" cy="19229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68389" y="5365378"/>
            <a:ext cx="2731633" cy="63201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文本框 7"/>
          <p:cNvSpPr txBox="1"/>
          <p:nvPr/>
        </p:nvSpPr>
        <p:spPr>
          <a:xfrm>
            <a:off x="2704286" y="1327067"/>
            <a:ext cx="26789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: APEX2-FLAG-GRB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857123" y="2200838"/>
            <a:ext cx="6320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Dox:     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547403" y="2200838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2955296" y="2200838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264577" y="2200838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618682" y="2200838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3950376" y="2200838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4304481" y="2200838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4613762" y="2200838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4967867" y="2200838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861605" y="2487708"/>
            <a:ext cx="9054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</a:t>
            </a:r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O</a:t>
            </a:r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:     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2551886" y="2487708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2959779" y="2487708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3269060" y="2487708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3623165" y="2487708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3954859" y="2487708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4308964" y="2487708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4618245" y="2487708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4972350" y="2487708"/>
            <a:ext cx="3182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+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7" name="直接连接符 26"/>
          <p:cNvCxnSpPr/>
          <p:nvPr/>
        </p:nvCxnSpPr>
        <p:spPr>
          <a:xfrm>
            <a:off x="2596710" y="2180664"/>
            <a:ext cx="126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直接连接符 27"/>
          <p:cNvCxnSpPr/>
          <p:nvPr/>
        </p:nvCxnSpPr>
        <p:spPr>
          <a:xfrm>
            <a:off x="4040023" y="2180664"/>
            <a:ext cx="126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文本框 28"/>
          <p:cNvSpPr txBox="1"/>
          <p:nvPr/>
        </p:nvSpPr>
        <p:spPr>
          <a:xfrm>
            <a:off x="2944323" y="1828800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1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4374188" y="1860177"/>
            <a:ext cx="5709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BP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31" name="图片 30"/>
          <p:cNvPicPr>
            <a:picLocks noChangeAspect="1"/>
          </p:cNvPicPr>
          <p:nvPr/>
        </p:nvPicPr>
        <p:blipFill rotWithShape="1">
          <a:blip r:embed="rId4"/>
          <a:srcRect t="28203" b="25679"/>
          <a:stretch/>
        </p:blipFill>
        <p:spPr>
          <a:xfrm>
            <a:off x="2568868" y="4773109"/>
            <a:ext cx="2731155" cy="51817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2" name="文本框 31"/>
          <p:cNvSpPr txBox="1"/>
          <p:nvPr/>
        </p:nvSpPr>
        <p:spPr>
          <a:xfrm>
            <a:off x="5300022" y="3630409"/>
            <a:ext cx="17668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treptavidin-HRP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5300022" y="4718731"/>
            <a:ext cx="221246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FLAG </a:t>
            </a:r>
          </a:p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PEX2-FLAG-GRB2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5286116" y="5508543"/>
            <a:ext cx="120097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</a:t>
            </a:r>
            <a:r>
              <a:rPr lang="el-GR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β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-actin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2045374" y="5605436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6" name="直接连接符 35"/>
          <p:cNvCxnSpPr/>
          <p:nvPr/>
        </p:nvCxnSpPr>
        <p:spPr>
          <a:xfrm>
            <a:off x="2444312" y="5759825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文本框 36"/>
          <p:cNvSpPr txBox="1"/>
          <p:nvPr/>
        </p:nvSpPr>
        <p:spPr>
          <a:xfrm>
            <a:off x="2036410" y="5327532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8" name="直接连接符 37"/>
          <p:cNvCxnSpPr/>
          <p:nvPr/>
        </p:nvCxnSpPr>
        <p:spPr>
          <a:xfrm>
            <a:off x="2444312" y="5481921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文本框 40"/>
          <p:cNvSpPr txBox="1"/>
          <p:nvPr/>
        </p:nvSpPr>
        <p:spPr>
          <a:xfrm>
            <a:off x="2036410" y="4910675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42" name="直接连接符 41"/>
          <p:cNvCxnSpPr/>
          <p:nvPr/>
        </p:nvCxnSpPr>
        <p:spPr>
          <a:xfrm>
            <a:off x="2444312" y="5065064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文本框 42"/>
          <p:cNvSpPr txBox="1"/>
          <p:nvPr/>
        </p:nvSpPr>
        <p:spPr>
          <a:xfrm>
            <a:off x="2027446" y="4713453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7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44" name="直接连接符 43"/>
          <p:cNvCxnSpPr/>
          <p:nvPr/>
        </p:nvCxnSpPr>
        <p:spPr>
          <a:xfrm>
            <a:off x="2444312" y="4867842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561239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54095" y="695779"/>
            <a:ext cx="2204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Quantification (n=3)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095" y="1467853"/>
            <a:ext cx="8835810" cy="39222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42384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3</TotalTime>
  <Words>131</Words>
  <Application>Microsoft Office PowerPoint</Application>
  <PresentationFormat>全屏显示(4:3)</PresentationFormat>
  <Paragraphs>91</Paragraphs>
  <Slides>4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Arial Unicode MS</vt:lpstr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Company>SUST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12</cp:revision>
  <dcterms:created xsi:type="dcterms:W3CDTF">2020-08-31T01:15:37Z</dcterms:created>
  <dcterms:modified xsi:type="dcterms:W3CDTF">2020-10-09T02:34:50Z</dcterms:modified>
</cp:coreProperties>
</file>